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3168650" cy="5759450"/>
  <p:notesSz cx="6858000" cy="9144000"/>
  <p:defaultTextStyle>
    <a:defPPr>
      <a:defRPr lang="es-ES_tradnl"/>
    </a:defPPr>
    <a:lvl1pPr marL="0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1pPr>
    <a:lvl2pPr marL="231572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2pPr>
    <a:lvl3pPr marL="463144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3pPr>
    <a:lvl4pPr marL="694715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4pPr>
    <a:lvl5pPr marL="926287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5pPr>
    <a:lvl6pPr marL="1157859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6pPr>
    <a:lvl7pPr marL="1389431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7pPr>
    <a:lvl8pPr marL="1621003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8pPr>
    <a:lvl9pPr marL="1852574" algn="l" defTabSz="463144" rtl="0" eaLnBrk="1" latinLnBrk="0" hangingPunct="1">
      <a:defRPr sz="91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14" userDrawn="1">
          <p15:clr>
            <a:srgbClr val="A4A3A4"/>
          </p15:clr>
        </p15:guide>
        <p15:guide id="2" pos="99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C15F3"/>
    <a:srgbClr val="F6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180"/>
    <p:restoredTop sz="94051"/>
  </p:normalViewPr>
  <p:slideViewPr>
    <p:cSldViewPr snapToGrid="0" snapToObjects="1" showGuides="1">
      <p:cViewPr>
        <p:scale>
          <a:sx n="247" d="100"/>
          <a:sy n="247" d="100"/>
        </p:scale>
        <p:origin x="144" y="-1208"/>
      </p:cViewPr>
      <p:guideLst>
        <p:guide orient="horz" pos="1814"/>
        <p:guide pos="99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7077F9-CB6E-9046-9338-A32B5BF5AB50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81275" y="1143000"/>
            <a:ext cx="1695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s-ES_tradn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8394FE-FECA-A444-A725-B0E2E3E5773A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92178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1pPr>
    <a:lvl2pPr marL="231572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2pPr>
    <a:lvl3pPr marL="463144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3pPr>
    <a:lvl4pPr marL="694715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4pPr>
    <a:lvl5pPr marL="926287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5pPr>
    <a:lvl6pPr marL="1157859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6pPr>
    <a:lvl7pPr marL="1389431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7pPr>
    <a:lvl8pPr marL="1621003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8pPr>
    <a:lvl9pPr marL="1852574" algn="l" defTabSz="463144" rtl="0" eaLnBrk="1" latinLnBrk="0" hangingPunct="1">
      <a:defRPr sz="60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581275" y="1143000"/>
            <a:ext cx="1695450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58394FE-FECA-A444-A725-B0E2E3E5773A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981709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7649" y="942577"/>
            <a:ext cx="2693353" cy="2005142"/>
          </a:xfrm>
        </p:spPr>
        <p:txBody>
          <a:bodyPr anchor="b"/>
          <a:lstStyle>
            <a:lvl1pPr algn="ctr">
              <a:defRPr sz="2079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96081" y="3025045"/>
            <a:ext cx="2376488" cy="1390533"/>
          </a:xfrm>
        </p:spPr>
        <p:txBody>
          <a:bodyPr/>
          <a:lstStyle>
            <a:lvl1pPr marL="0" indent="0" algn="ctr">
              <a:buNone/>
              <a:defRPr sz="832"/>
            </a:lvl1pPr>
            <a:lvl2pPr marL="158420" indent="0" algn="ctr">
              <a:buNone/>
              <a:defRPr sz="693"/>
            </a:lvl2pPr>
            <a:lvl3pPr marL="316840" indent="0" algn="ctr">
              <a:buNone/>
              <a:defRPr sz="624"/>
            </a:lvl3pPr>
            <a:lvl4pPr marL="475259" indent="0" algn="ctr">
              <a:buNone/>
              <a:defRPr sz="554"/>
            </a:lvl4pPr>
            <a:lvl5pPr marL="633679" indent="0" algn="ctr">
              <a:buNone/>
              <a:defRPr sz="554"/>
            </a:lvl5pPr>
            <a:lvl6pPr marL="792099" indent="0" algn="ctr">
              <a:buNone/>
              <a:defRPr sz="554"/>
            </a:lvl6pPr>
            <a:lvl7pPr marL="950519" indent="0" algn="ctr">
              <a:buNone/>
              <a:defRPr sz="554"/>
            </a:lvl7pPr>
            <a:lvl8pPr marL="1108939" indent="0" algn="ctr">
              <a:buNone/>
              <a:defRPr sz="554"/>
            </a:lvl8pPr>
            <a:lvl9pPr marL="1267358" indent="0" algn="ctr">
              <a:buNone/>
              <a:defRPr sz="554"/>
            </a:lvl9pPr>
          </a:lstStyle>
          <a:p>
            <a:r>
              <a:rPr lang="es-ES_tradnl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93554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9604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67565" y="306637"/>
            <a:ext cx="683240" cy="4880868"/>
          </a:xfrm>
        </p:spPr>
        <p:txBody>
          <a:bodyPr vert="eaVert"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7845" y="306637"/>
            <a:ext cx="2010112" cy="4880868"/>
          </a:xfrm>
        </p:spPr>
        <p:txBody>
          <a:bodyPr vert="eaVert"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34041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012398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6194" y="1435864"/>
            <a:ext cx="2732961" cy="2395771"/>
          </a:xfrm>
        </p:spPr>
        <p:txBody>
          <a:bodyPr anchor="b"/>
          <a:lstStyle>
            <a:lvl1pPr>
              <a:defRPr sz="2079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6194" y="3854300"/>
            <a:ext cx="2732961" cy="1259879"/>
          </a:xfrm>
        </p:spPr>
        <p:txBody>
          <a:bodyPr/>
          <a:lstStyle>
            <a:lvl1pPr marL="0" indent="0">
              <a:buNone/>
              <a:defRPr sz="832">
                <a:solidFill>
                  <a:schemeClr val="tx1"/>
                </a:solidFill>
              </a:defRPr>
            </a:lvl1pPr>
            <a:lvl2pPr marL="158420" indent="0">
              <a:buNone/>
              <a:defRPr sz="693">
                <a:solidFill>
                  <a:schemeClr val="tx1">
                    <a:tint val="75000"/>
                  </a:schemeClr>
                </a:solidFill>
              </a:defRPr>
            </a:lvl2pPr>
            <a:lvl3pPr marL="316840" indent="0">
              <a:buNone/>
              <a:defRPr sz="624">
                <a:solidFill>
                  <a:schemeClr val="tx1">
                    <a:tint val="75000"/>
                  </a:schemeClr>
                </a:solidFill>
              </a:defRPr>
            </a:lvl3pPr>
            <a:lvl4pPr marL="47525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4pPr>
            <a:lvl5pPr marL="63367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5pPr>
            <a:lvl6pPr marL="79209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6pPr>
            <a:lvl7pPr marL="95051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7pPr>
            <a:lvl8pPr marL="1108939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8pPr>
            <a:lvl9pPr marL="1267358" indent="0">
              <a:buNone/>
              <a:defRPr sz="55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72402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7845" y="1533187"/>
            <a:ext cx="1346676" cy="3654318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04129" y="1533187"/>
            <a:ext cx="1346676" cy="3654318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5942618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306639"/>
            <a:ext cx="2732961" cy="1113227"/>
          </a:xfrm>
        </p:spPr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8258" y="1411865"/>
            <a:ext cx="1340487" cy="691934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420" indent="0">
              <a:buNone/>
              <a:defRPr sz="693" b="1"/>
            </a:lvl2pPr>
            <a:lvl3pPr marL="316840" indent="0">
              <a:buNone/>
              <a:defRPr sz="624" b="1"/>
            </a:lvl3pPr>
            <a:lvl4pPr marL="475259" indent="0">
              <a:buNone/>
              <a:defRPr sz="554" b="1"/>
            </a:lvl4pPr>
            <a:lvl5pPr marL="633679" indent="0">
              <a:buNone/>
              <a:defRPr sz="554" b="1"/>
            </a:lvl5pPr>
            <a:lvl6pPr marL="792099" indent="0">
              <a:buNone/>
              <a:defRPr sz="554" b="1"/>
            </a:lvl6pPr>
            <a:lvl7pPr marL="950519" indent="0">
              <a:buNone/>
              <a:defRPr sz="554" b="1"/>
            </a:lvl7pPr>
            <a:lvl8pPr marL="1108939" indent="0">
              <a:buNone/>
              <a:defRPr sz="554" b="1"/>
            </a:lvl8pPr>
            <a:lvl9pPr marL="1267358" indent="0">
              <a:buNone/>
              <a:defRPr sz="55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258" y="2103799"/>
            <a:ext cx="1340487" cy="3094372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04129" y="1411865"/>
            <a:ext cx="1347089" cy="691934"/>
          </a:xfrm>
        </p:spPr>
        <p:txBody>
          <a:bodyPr anchor="b"/>
          <a:lstStyle>
            <a:lvl1pPr marL="0" indent="0">
              <a:buNone/>
              <a:defRPr sz="832" b="1"/>
            </a:lvl1pPr>
            <a:lvl2pPr marL="158420" indent="0">
              <a:buNone/>
              <a:defRPr sz="693" b="1"/>
            </a:lvl2pPr>
            <a:lvl3pPr marL="316840" indent="0">
              <a:buNone/>
              <a:defRPr sz="624" b="1"/>
            </a:lvl3pPr>
            <a:lvl4pPr marL="475259" indent="0">
              <a:buNone/>
              <a:defRPr sz="554" b="1"/>
            </a:lvl4pPr>
            <a:lvl5pPr marL="633679" indent="0">
              <a:buNone/>
              <a:defRPr sz="554" b="1"/>
            </a:lvl5pPr>
            <a:lvl6pPr marL="792099" indent="0">
              <a:buNone/>
              <a:defRPr sz="554" b="1"/>
            </a:lvl6pPr>
            <a:lvl7pPr marL="950519" indent="0">
              <a:buNone/>
              <a:defRPr sz="554" b="1"/>
            </a:lvl7pPr>
            <a:lvl8pPr marL="1108939" indent="0">
              <a:buNone/>
              <a:defRPr sz="554" b="1"/>
            </a:lvl8pPr>
            <a:lvl9pPr marL="1267358" indent="0">
              <a:buNone/>
              <a:defRPr sz="554" b="1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04129" y="2103799"/>
            <a:ext cx="1347089" cy="3094372"/>
          </a:xfrm>
        </p:spPr>
        <p:txBody>
          <a:bodyPr/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06138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53453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44439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383963"/>
            <a:ext cx="1021972" cy="1343872"/>
          </a:xfrm>
        </p:spPr>
        <p:txBody>
          <a:bodyPr anchor="b"/>
          <a:lstStyle>
            <a:lvl1pPr>
              <a:defRPr sz="1109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47089" y="829256"/>
            <a:ext cx="1604129" cy="4092942"/>
          </a:xfrm>
        </p:spPr>
        <p:txBody>
          <a:bodyPr/>
          <a:lstStyle>
            <a:lvl1pPr>
              <a:defRPr sz="1109"/>
            </a:lvl1pPr>
            <a:lvl2pPr>
              <a:defRPr sz="970"/>
            </a:lvl2pPr>
            <a:lvl3pPr>
              <a:defRPr sz="832"/>
            </a:lvl3pPr>
            <a:lvl4pPr>
              <a:defRPr sz="693"/>
            </a:lvl4pPr>
            <a:lvl5pPr>
              <a:defRPr sz="693"/>
            </a:lvl5pPr>
            <a:lvl6pPr>
              <a:defRPr sz="693"/>
            </a:lvl6pPr>
            <a:lvl7pPr>
              <a:defRPr sz="693"/>
            </a:lvl7pPr>
            <a:lvl8pPr>
              <a:defRPr sz="693"/>
            </a:lvl8pPr>
            <a:lvl9pPr>
              <a:defRPr sz="693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8257" y="1727835"/>
            <a:ext cx="1021972" cy="3201028"/>
          </a:xfrm>
        </p:spPr>
        <p:txBody>
          <a:bodyPr/>
          <a:lstStyle>
            <a:lvl1pPr marL="0" indent="0">
              <a:buNone/>
              <a:defRPr sz="554"/>
            </a:lvl1pPr>
            <a:lvl2pPr marL="158420" indent="0">
              <a:buNone/>
              <a:defRPr sz="485"/>
            </a:lvl2pPr>
            <a:lvl3pPr marL="316840" indent="0">
              <a:buNone/>
              <a:defRPr sz="416"/>
            </a:lvl3pPr>
            <a:lvl4pPr marL="475259" indent="0">
              <a:buNone/>
              <a:defRPr sz="347"/>
            </a:lvl4pPr>
            <a:lvl5pPr marL="633679" indent="0">
              <a:buNone/>
              <a:defRPr sz="347"/>
            </a:lvl5pPr>
            <a:lvl6pPr marL="792099" indent="0">
              <a:buNone/>
              <a:defRPr sz="347"/>
            </a:lvl6pPr>
            <a:lvl7pPr marL="950519" indent="0">
              <a:buNone/>
              <a:defRPr sz="347"/>
            </a:lvl7pPr>
            <a:lvl8pPr marL="1108939" indent="0">
              <a:buNone/>
              <a:defRPr sz="347"/>
            </a:lvl8pPr>
            <a:lvl9pPr marL="1267358" indent="0">
              <a:buNone/>
              <a:defRPr sz="347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347927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257" y="383963"/>
            <a:ext cx="1021972" cy="1343872"/>
          </a:xfrm>
        </p:spPr>
        <p:txBody>
          <a:bodyPr anchor="b"/>
          <a:lstStyle>
            <a:lvl1pPr>
              <a:defRPr sz="1109"/>
            </a:lvl1pPr>
          </a:lstStyle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47089" y="829256"/>
            <a:ext cx="1604129" cy="4092942"/>
          </a:xfrm>
        </p:spPr>
        <p:txBody>
          <a:bodyPr anchor="t"/>
          <a:lstStyle>
            <a:lvl1pPr marL="0" indent="0">
              <a:buNone/>
              <a:defRPr sz="1109"/>
            </a:lvl1pPr>
            <a:lvl2pPr marL="158420" indent="0">
              <a:buNone/>
              <a:defRPr sz="970"/>
            </a:lvl2pPr>
            <a:lvl3pPr marL="316840" indent="0">
              <a:buNone/>
              <a:defRPr sz="832"/>
            </a:lvl3pPr>
            <a:lvl4pPr marL="475259" indent="0">
              <a:buNone/>
              <a:defRPr sz="693"/>
            </a:lvl4pPr>
            <a:lvl5pPr marL="633679" indent="0">
              <a:buNone/>
              <a:defRPr sz="693"/>
            </a:lvl5pPr>
            <a:lvl6pPr marL="792099" indent="0">
              <a:buNone/>
              <a:defRPr sz="693"/>
            </a:lvl6pPr>
            <a:lvl7pPr marL="950519" indent="0">
              <a:buNone/>
              <a:defRPr sz="693"/>
            </a:lvl7pPr>
            <a:lvl8pPr marL="1108939" indent="0">
              <a:buNone/>
              <a:defRPr sz="693"/>
            </a:lvl8pPr>
            <a:lvl9pPr marL="1267358" indent="0">
              <a:buNone/>
              <a:defRPr sz="693"/>
            </a:lvl9pPr>
          </a:lstStyle>
          <a:p>
            <a:r>
              <a:rPr lang="es-ES_tradnl" smtClean="0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8257" y="1727835"/>
            <a:ext cx="1021972" cy="3201028"/>
          </a:xfrm>
        </p:spPr>
        <p:txBody>
          <a:bodyPr/>
          <a:lstStyle>
            <a:lvl1pPr marL="0" indent="0">
              <a:buNone/>
              <a:defRPr sz="554"/>
            </a:lvl1pPr>
            <a:lvl2pPr marL="158420" indent="0">
              <a:buNone/>
              <a:defRPr sz="485"/>
            </a:lvl2pPr>
            <a:lvl3pPr marL="316840" indent="0">
              <a:buNone/>
              <a:defRPr sz="416"/>
            </a:lvl3pPr>
            <a:lvl4pPr marL="475259" indent="0">
              <a:buNone/>
              <a:defRPr sz="347"/>
            </a:lvl4pPr>
            <a:lvl5pPr marL="633679" indent="0">
              <a:buNone/>
              <a:defRPr sz="347"/>
            </a:lvl5pPr>
            <a:lvl6pPr marL="792099" indent="0">
              <a:buNone/>
              <a:defRPr sz="347"/>
            </a:lvl6pPr>
            <a:lvl7pPr marL="950519" indent="0">
              <a:buNone/>
              <a:defRPr sz="347"/>
            </a:lvl7pPr>
            <a:lvl8pPr marL="1108939" indent="0">
              <a:buNone/>
              <a:defRPr sz="347"/>
            </a:lvl8pPr>
            <a:lvl9pPr marL="1267358" indent="0">
              <a:buNone/>
              <a:defRPr sz="347"/>
            </a:lvl9pPr>
          </a:lstStyle>
          <a:p>
            <a:pPr lvl="0"/>
            <a:r>
              <a:rPr lang="es-ES_tradnl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8151221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7845" y="306639"/>
            <a:ext cx="2732961" cy="11132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 para editar títu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7845" y="1533187"/>
            <a:ext cx="2732961" cy="36543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Haga clic para modificar el estilo de texto del patrón</a:t>
            </a:r>
          </a:p>
          <a:p>
            <a:pPr lvl="1"/>
            <a:r>
              <a:rPr lang="es-ES_tradnl" smtClean="0"/>
              <a:t>Segundo nivel</a:t>
            </a:r>
          </a:p>
          <a:p>
            <a:pPr lvl="2"/>
            <a:r>
              <a:rPr lang="es-ES_tradnl" smtClean="0"/>
              <a:t>Tercer nivel</a:t>
            </a:r>
          </a:p>
          <a:p>
            <a:pPr lvl="3"/>
            <a:r>
              <a:rPr lang="es-ES_tradnl" smtClean="0"/>
              <a:t>Cuarto nivel</a:t>
            </a:r>
          </a:p>
          <a:p>
            <a:pPr lvl="4"/>
            <a:r>
              <a:rPr lang="es-ES_tradnl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7845" y="5338158"/>
            <a:ext cx="712946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3E3F40-3B15-764C-B50A-045BAF9290DA}" type="datetimeFigureOut">
              <a:rPr lang="es-ES_tradnl" smtClean="0"/>
              <a:t>25/5/20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49616" y="5338158"/>
            <a:ext cx="1069419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37859" y="5338158"/>
            <a:ext cx="712946" cy="306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862741-083A-7A42-A19A-9314315385C8}" type="slidenum">
              <a:rPr lang="es-ES_tradnl" smtClean="0"/>
              <a:t>‹Nr.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194889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316840" rtl="0" eaLnBrk="1" latinLnBrk="0" hangingPunct="1">
        <a:lnSpc>
          <a:spcPct val="90000"/>
        </a:lnSpc>
        <a:spcBef>
          <a:spcPct val="0"/>
        </a:spcBef>
        <a:buNone/>
        <a:defRPr sz="152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9210" indent="-79210" algn="l" defTabSz="316840" rtl="0" eaLnBrk="1" latinLnBrk="0" hangingPunct="1">
        <a:lnSpc>
          <a:spcPct val="90000"/>
        </a:lnSpc>
        <a:spcBef>
          <a:spcPts val="347"/>
        </a:spcBef>
        <a:buFont typeface="Arial" panose="020B0604020202020204" pitchFamily="34" charset="0"/>
        <a:buChar char="•"/>
        <a:defRPr sz="970" kern="1200">
          <a:solidFill>
            <a:schemeClr val="tx1"/>
          </a:solidFill>
          <a:latin typeface="+mn-lt"/>
          <a:ea typeface="+mn-ea"/>
          <a:cs typeface="+mn-cs"/>
        </a:defRPr>
      </a:lvl1pPr>
      <a:lvl2pPr marL="237630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832" kern="1200">
          <a:solidFill>
            <a:schemeClr val="tx1"/>
          </a:solidFill>
          <a:latin typeface="+mn-lt"/>
          <a:ea typeface="+mn-ea"/>
          <a:cs typeface="+mn-cs"/>
        </a:defRPr>
      </a:lvl2pPr>
      <a:lvl3pPr marL="396050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93" kern="1200">
          <a:solidFill>
            <a:schemeClr val="tx1"/>
          </a:solidFill>
          <a:latin typeface="+mn-lt"/>
          <a:ea typeface="+mn-ea"/>
          <a:cs typeface="+mn-cs"/>
        </a:defRPr>
      </a:lvl3pPr>
      <a:lvl4pPr marL="55446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71288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87130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102972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88149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346568" indent="-79210" algn="l" defTabSz="316840" rtl="0" eaLnBrk="1" latinLnBrk="0" hangingPunct="1">
        <a:lnSpc>
          <a:spcPct val="90000"/>
        </a:lnSpc>
        <a:spcBef>
          <a:spcPts val="173"/>
        </a:spcBef>
        <a:buFont typeface="Arial" panose="020B0604020202020204" pitchFamily="34" charset="0"/>
        <a:buChar char="•"/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1pPr>
      <a:lvl2pPr marL="15842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2pPr>
      <a:lvl3pPr marL="316840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3pPr>
      <a:lvl4pPr marL="47525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4pPr>
      <a:lvl5pPr marL="63367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5pPr>
      <a:lvl6pPr marL="79209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6pPr>
      <a:lvl7pPr marL="95051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7pPr>
      <a:lvl8pPr marL="1108939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8pPr>
      <a:lvl9pPr marL="1267358" algn="l" defTabSz="316840" rtl="0" eaLnBrk="1" latinLnBrk="0" hangingPunct="1">
        <a:defRPr sz="6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7" Type="http://schemas.openxmlformats.org/officeDocument/2006/relationships/image" Target="../media/image5.tif"/><Relationship Id="rId8" Type="http://schemas.openxmlformats.org/officeDocument/2006/relationships/image" Target="../media/image6.tiff"/><Relationship Id="rId9" Type="http://schemas.openxmlformats.org/officeDocument/2006/relationships/image" Target="../media/image7.t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n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010" y="79756"/>
            <a:ext cx="864108" cy="864108"/>
          </a:xfrm>
          <a:prstGeom prst="rect">
            <a:avLst/>
          </a:prstGeom>
        </p:spPr>
      </p:pic>
      <p:pic>
        <p:nvPicPr>
          <p:cNvPr id="15" name="Imagen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210" y="79756"/>
            <a:ext cx="1917192" cy="3549396"/>
          </a:xfrm>
          <a:prstGeom prst="rect">
            <a:avLst/>
          </a:prstGeom>
        </p:spPr>
      </p:pic>
      <p:pic>
        <p:nvPicPr>
          <p:cNvPr id="16" name="Imagen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010" y="978725"/>
            <a:ext cx="864108" cy="864108"/>
          </a:xfrm>
          <a:prstGeom prst="rect">
            <a:avLst/>
          </a:prstGeom>
        </p:spPr>
      </p:pic>
      <p:pic>
        <p:nvPicPr>
          <p:cNvPr id="17" name="Imagen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010" y="1877694"/>
            <a:ext cx="864108" cy="864108"/>
          </a:xfrm>
          <a:prstGeom prst="rect">
            <a:avLst/>
          </a:prstGeom>
        </p:spPr>
      </p:pic>
      <p:pic>
        <p:nvPicPr>
          <p:cNvPr id="18" name="Imagen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4010" y="2765044"/>
            <a:ext cx="864108" cy="864108"/>
          </a:xfrm>
          <a:prstGeom prst="rect">
            <a:avLst/>
          </a:prstGeom>
        </p:spPr>
      </p:pic>
      <p:pic>
        <p:nvPicPr>
          <p:cNvPr id="23" name="Imagen 2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735" y="3709472"/>
            <a:ext cx="2667000" cy="1460500"/>
          </a:xfrm>
          <a:prstGeom prst="rect">
            <a:avLst/>
          </a:prstGeom>
        </p:spPr>
      </p:pic>
      <p:sp>
        <p:nvSpPr>
          <p:cNvPr id="24" name="CuadroTexto 23"/>
          <p:cNvSpPr txBox="1"/>
          <p:nvPr/>
        </p:nvSpPr>
        <p:spPr>
          <a:xfrm>
            <a:off x="217301" y="3610463"/>
            <a:ext cx="81770" cy="206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>
                <a:latin typeface="Arial" charset="0"/>
                <a:ea typeface="Arial" charset="0"/>
                <a:cs typeface="Arial" charset="0"/>
              </a:rPr>
              <a:t>C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944272" y="3686976"/>
            <a:ext cx="14257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Cingulate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cortex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s-ES_tradnl" sz="600" dirty="0" err="1" smtClean="0">
                <a:latin typeface="Arial" charset="0"/>
                <a:ea typeface="Arial" charset="0"/>
                <a:cs typeface="Arial" charset="0"/>
              </a:rPr>
              <a:t>area</a:t>
            </a:r>
            <a:r>
              <a:rPr lang="es-ES_tradnl" sz="600" dirty="0" smtClean="0">
                <a:latin typeface="Arial" charset="0"/>
                <a:ea typeface="Arial" charset="0"/>
                <a:cs typeface="Arial" charset="0"/>
              </a:rPr>
              <a:t> 1</a:t>
            </a:r>
            <a:endParaRPr lang="es-ES_tradnl" sz="6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6" name="Agrupar 25"/>
          <p:cNvGrpSpPr/>
          <p:nvPr/>
        </p:nvGrpSpPr>
        <p:grpSpPr>
          <a:xfrm>
            <a:off x="1051402" y="5104060"/>
            <a:ext cx="1527918" cy="193387"/>
            <a:chOff x="4006827" y="1637550"/>
            <a:chExt cx="1527918" cy="193387"/>
          </a:xfrm>
        </p:grpSpPr>
        <p:sp>
          <p:nvSpPr>
            <p:cNvPr id="32" name="CuadroTexto 31"/>
            <p:cNvSpPr txBox="1"/>
            <p:nvPr/>
          </p:nvSpPr>
          <p:spPr>
            <a:xfrm>
              <a:off x="4006827" y="1642575"/>
              <a:ext cx="2937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600" b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PV</a:t>
              </a:r>
              <a:endParaRPr lang="es-ES_tradnl" sz="6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3" name="CuadroTexto 32"/>
            <p:cNvSpPr txBox="1"/>
            <p:nvPr/>
          </p:nvSpPr>
          <p:spPr>
            <a:xfrm>
              <a:off x="4543711" y="1646271"/>
              <a:ext cx="3597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600" b="1" smtClean="0">
                  <a:solidFill>
                    <a:srgbClr val="254E9E"/>
                  </a:solidFill>
                  <a:latin typeface="Arial" charset="0"/>
                  <a:ea typeface="Arial" charset="0"/>
                  <a:cs typeface="Arial" charset="0"/>
                </a:rPr>
                <a:t>PNN</a:t>
              </a:r>
              <a:endParaRPr lang="es-ES_tradnl" sz="600" b="1" dirty="0">
                <a:solidFill>
                  <a:srgbClr val="254E9E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5040196" y="1637550"/>
              <a:ext cx="4945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s-ES_tradnl" sz="600" b="1" dirty="0" smtClean="0">
                  <a:latin typeface="Arial" charset="0"/>
                  <a:ea typeface="Arial" charset="0"/>
                  <a:cs typeface="Arial" charset="0"/>
                </a:rPr>
                <a:t>PV_PNN</a:t>
              </a:r>
              <a:endParaRPr lang="es-ES_tradnl" sz="600" b="1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7" name="Agrupar 26"/>
          <p:cNvGrpSpPr/>
          <p:nvPr/>
        </p:nvGrpSpPr>
        <p:grpSpPr>
          <a:xfrm>
            <a:off x="1445979" y="5297447"/>
            <a:ext cx="826917" cy="184733"/>
            <a:chOff x="4440051" y="3502654"/>
            <a:chExt cx="826917" cy="184733"/>
          </a:xfrm>
        </p:grpSpPr>
        <p:sp>
          <p:nvSpPr>
            <p:cNvPr id="28" name="CuadroTexto 27"/>
            <p:cNvSpPr txBox="1"/>
            <p:nvPr/>
          </p:nvSpPr>
          <p:spPr>
            <a:xfrm>
              <a:off x="4443174" y="3502654"/>
              <a:ext cx="41916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600" dirty="0">
                  <a:latin typeface="Arial" charset="0"/>
                  <a:ea typeface="Arial" charset="0"/>
                  <a:cs typeface="Arial" charset="0"/>
                </a:rPr>
                <a:t>VEH</a:t>
              </a:r>
            </a:p>
          </p:txBody>
        </p:sp>
        <p:sp>
          <p:nvSpPr>
            <p:cNvPr id="29" name="CuadroTexto 28"/>
            <p:cNvSpPr txBox="1"/>
            <p:nvPr/>
          </p:nvSpPr>
          <p:spPr>
            <a:xfrm>
              <a:off x="4847806" y="3502721"/>
              <a:ext cx="41916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s-ES_tradnl" sz="600" dirty="0">
                  <a:latin typeface="Arial" charset="0"/>
                  <a:ea typeface="Arial" charset="0"/>
                  <a:cs typeface="Arial" charset="0"/>
                </a:rPr>
                <a:t>THC</a:t>
              </a:r>
            </a:p>
          </p:txBody>
        </p:sp>
        <p:sp>
          <p:nvSpPr>
            <p:cNvPr id="30" name="Rectángulo 29"/>
            <p:cNvSpPr/>
            <p:nvPr/>
          </p:nvSpPr>
          <p:spPr>
            <a:xfrm>
              <a:off x="4440051" y="3565032"/>
              <a:ext cx="54871" cy="54871"/>
            </a:xfrm>
            <a:prstGeom prst="rect">
              <a:avLst/>
            </a:prstGeom>
            <a:solidFill>
              <a:srgbClr val="BFC336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 sz="600"/>
            </a:p>
          </p:txBody>
        </p:sp>
        <p:sp>
          <p:nvSpPr>
            <p:cNvPr id="31" name="Rectángulo 30"/>
            <p:cNvSpPr/>
            <p:nvPr/>
          </p:nvSpPr>
          <p:spPr>
            <a:xfrm>
              <a:off x="4847807" y="3565031"/>
              <a:ext cx="54871" cy="54871"/>
            </a:xfrm>
            <a:prstGeom prst="rect">
              <a:avLst/>
            </a:prstGeom>
            <a:solidFill>
              <a:srgbClr val="172C90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s-ES_tradnl"/>
              </a:defPPr>
              <a:lvl1pPr marL="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25918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51837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77756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03674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129593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1555120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1814307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2073493" algn="l" defTabSz="518373" rtl="0" eaLnBrk="1" latinLnBrk="0" hangingPunct="1">
                <a:defRPr sz="102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s-ES_tradnl" sz="600"/>
            </a:p>
          </p:txBody>
        </p:sp>
      </p:grpSp>
      <p:pic>
        <p:nvPicPr>
          <p:cNvPr id="35" name="Imagen 3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3247" y="3572898"/>
            <a:ext cx="147828" cy="22860"/>
          </a:xfrm>
          <a:prstGeom prst="rect">
            <a:avLst/>
          </a:prstGeom>
        </p:spPr>
      </p:pic>
      <p:sp>
        <p:nvSpPr>
          <p:cNvPr id="36" name="CuadroTexto 35"/>
          <p:cNvSpPr txBox="1"/>
          <p:nvPr/>
        </p:nvSpPr>
        <p:spPr>
          <a:xfrm>
            <a:off x="139874" y="55436"/>
            <a:ext cx="300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1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CuadroTexto 36"/>
          <p:cNvSpPr txBox="1"/>
          <p:nvPr/>
        </p:nvSpPr>
        <p:spPr>
          <a:xfrm>
            <a:off x="2069387" y="44895"/>
            <a:ext cx="300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2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CuadroTexto 37"/>
          <p:cNvSpPr txBox="1"/>
          <p:nvPr/>
        </p:nvSpPr>
        <p:spPr>
          <a:xfrm>
            <a:off x="2092497" y="2729938"/>
            <a:ext cx="300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5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2092498" y="1845366"/>
            <a:ext cx="300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4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2079594" y="946397"/>
            <a:ext cx="30066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A3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Forma libre 48"/>
          <p:cNvSpPr/>
          <p:nvPr/>
        </p:nvSpPr>
        <p:spPr>
          <a:xfrm>
            <a:off x="498720" y="898133"/>
            <a:ext cx="978003" cy="744417"/>
          </a:xfrm>
          <a:custGeom>
            <a:avLst/>
            <a:gdLst>
              <a:gd name="connsiteX0" fmla="*/ 20223 w 978003"/>
              <a:gd name="connsiteY0" fmla="*/ 281 h 744417"/>
              <a:gd name="connsiteX1" fmla="*/ 186478 w 978003"/>
              <a:gd name="connsiteY1" fmla="*/ 57831 h 744417"/>
              <a:gd name="connsiteX2" fmla="*/ 371915 w 978003"/>
              <a:gd name="connsiteY2" fmla="*/ 163339 h 744417"/>
              <a:gd name="connsiteX3" fmla="*/ 752383 w 978003"/>
              <a:gd name="connsiteY3" fmla="*/ 422312 h 744417"/>
              <a:gd name="connsiteX4" fmla="*/ 941017 w 978003"/>
              <a:gd name="connsiteY4" fmla="*/ 562989 h 744417"/>
              <a:gd name="connsiteX5" fmla="*/ 963398 w 978003"/>
              <a:gd name="connsiteY5" fmla="*/ 585370 h 744417"/>
              <a:gd name="connsiteX6" fmla="*/ 976187 w 978003"/>
              <a:gd name="connsiteY6" fmla="*/ 614144 h 744417"/>
              <a:gd name="connsiteX7" fmla="*/ 969792 w 978003"/>
              <a:gd name="connsiteY7" fmla="*/ 639722 h 744417"/>
              <a:gd name="connsiteX8" fmla="*/ 902651 w 978003"/>
              <a:gd name="connsiteY8" fmla="*/ 726046 h 744417"/>
              <a:gd name="connsiteX9" fmla="*/ 845101 w 978003"/>
              <a:gd name="connsiteY9" fmla="*/ 742032 h 744417"/>
              <a:gd name="connsiteX10" fmla="*/ 701227 w 978003"/>
              <a:gd name="connsiteY10" fmla="*/ 690877 h 744417"/>
              <a:gd name="connsiteX11" fmla="*/ 509395 w 978003"/>
              <a:gd name="connsiteY11" fmla="*/ 598158 h 744417"/>
              <a:gd name="connsiteX12" fmla="*/ 368718 w 978003"/>
              <a:gd name="connsiteY12" fmla="*/ 540609 h 744417"/>
              <a:gd name="connsiteX13" fmla="*/ 103350 w 978003"/>
              <a:gd name="connsiteY13" fmla="*/ 435101 h 744417"/>
              <a:gd name="connsiteX14" fmla="*/ 33012 w 978003"/>
              <a:gd name="connsiteY14" fmla="*/ 415918 h 744417"/>
              <a:gd name="connsiteX15" fmla="*/ 26617 w 978003"/>
              <a:gd name="connsiteY15" fmla="*/ 383946 h 744417"/>
              <a:gd name="connsiteX16" fmla="*/ 10631 w 978003"/>
              <a:gd name="connsiteY16" fmla="*/ 172930 h 744417"/>
              <a:gd name="connsiteX17" fmla="*/ 4237 w 978003"/>
              <a:gd name="connsiteY17" fmla="*/ 80211 h 744417"/>
              <a:gd name="connsiteX18" fmla="*/ 20223 w 978003"/>
              <a:gd name="connsiteY18" fmla="*/ 281 h 7444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978003" h="744417">
                <a:moveTo>
                  <a:pt x="20223" y="281"/>
                </a:moveTo>
                <a:cubicBezTo>
                  <a:pt x="50597" y="-3449"/>
                  <a:pt x="127863" y="30655"/>
                  <a:pt x="186478" y="57831"/>
                </a:cubicBezTo>
                <a:cubicBezTo>
                  <a:pt x="245093" y="85007"/>
                  <a:pt x="277598" y="102592"/>
                  <a:pt x="371915" y="163339"/>
                </a:cubicBezTo>
                <a:cubicBezTo>
                  <a:pt x="466232" y="224086"/>
                  <a:pt x="657533" y="355704"/>
                  <a:pt x="752383" y="422312"/>
                </a:cubicBezTo>
                <a:cubicBezTo>
                  <a:pt x="847233" y="488920"/>
                  <a:pt x="905848" y="535813"/>
                  <a:pt x="941017" y="562989"/>
                </a:cubicBezTo>
                <a:cubicBezTo>
                  <a:pt x="976186" y="590165"/>
                  <a:pt x="957536" y="576844"/>
                  <a:pt x="963398" y="585370"/>
                </a:cubicBezTo>
                <a:cubicBezTo>
                  <a:pt x="969260" y="593896"/>
                  <a:pt x="975121" y="605085"/>
                  <a:pt x="976187" y="614144"/>
                </a:cubicBezTo>
                <a:cubicBezTo>
                  <a:pt x="977253" y="623203"/>
                  <a:pt x="982048" y="621072"/>
                  <a:pt x="969792" y="639722"/>
                </a:cubicBezTo>
                <a:cubicBezTo>
                  <a:pt x="957536" y="658372"/>
                  <a:pt x="923433" y="708994"/>
                  <a:pt x="902651" y="726046"/>
                </a:cubicBezTo>
                <a:cubicBezTo>
                  <a:pt x="881869" y="743098"/>
                  <a:pt x="878672" y="747894"/>
                  <a:pt x="845101" y="742032"/>
                </a:cubicBezTo>
                <a:cubicBezTo>
                  <a:pt x="811530" y="736171"/>
                  <a:pt x="757178" y="714856"/>
                  <a:pt x="701227" y="690877"/>
                </a:cubicBezTo>
                <a:cubicBezTo>
                  <a:pt x="645276" y="666898"/>
                  <a:pt x="564813" y="623203"/>
                  <a:pt x="509395" y="598158"/>
                </a:cubicBezTo>
                <a:cubicBezTo>
                  <a:pt x="453977" y="573113"/>
                  <a:pt x="368718" y="540609"/>
                  <a:pt x="368718" y="540609"/>
                </a:cubicBezTo>
                <a:lnTo>
                  <a:pt x="103350" y="435101"/>
                </a:lnTo>
                <a:cubicBezTo>
                  <a:pt x="47399" y="414319"/>
                  <a:pt x="45801" y="424444"/>
                  <a:pt x="33012" y="415918"/>
                </a:cubicBezTo>
                <a:cubicBezTo>
                  <a:pt x="20223" y="407392"/>
                  <a:pt x="30347" y="424444"/>
                  <a:pt x="26617" y="383946"/>
                </a:cubicBezTo>
                <a:cubicBezTo>
                  <a:pt x="22887" y="343448"/>
                  <a:pt x="14361" y="223553"/>
                  <a:pt x="10631" y="172930"/>
                </a:cubicBezTo>
                <a:cubicBezTo>
                  <a:pt x="6901" y="122307"/>
                  <a:pt x="6368" y="110051"/>
                  <a:pt x="4237" y="80211"/>
                </a:cubicBezTo>
                <a:cubicBezTo>
                  <a:pt x="2106" y="50371"/>
                  <a:pt x="-10151" y="4011"/>
                  <a:pt x="20223" y="281"/>
                </a:cubicBezTo>
                <a:close/>
              </a:path>
            </a:pathLst>
          </a:custGeom>
          <a:noFill/>
          <a:ln w="6350" cap="flat">
            <a:solidFill>
              <a:schemeClr val="bg1">
                <a:alpha val="6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_tradnl"/>
          </a:p>
        </p:txBody>
      </p:sp>
      <p:sp>
        <p:nvSpPr>
          <p:cNvPr id="50" name="CuadroTexto 49"/>
          <p:cNvSpPr txBox="1"/>
          <p:nvPr/>
        </p:nvSpPr>
        <p:spPr>
          <a:xfrm>
            <a:off x="757625" y="1206366"/>
            <a:ext cx="32853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5918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51837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77756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03674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29593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555120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814307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073493" algn="l" defTabSz="518373" rtl="0" eaLnBrk="1" latinLnBrk="0" hangingPunct="1">
              <a:defRPr sz="102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6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g1</a:t>
            </a:r>
            <a:endParaRPr lang="es-ES_tradnl" sz="6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2" name="CuadroTexto 51"/>
          <p:cNvSpPr txBox="1"/>
          <p:nvPr/>
        </p:nvSpPr>
        <p:spPr>
          <a:xfrm>
            <a:off x="2063315" y="774276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VEH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3" name="CuadroTexto 52"/>
          <p:cNvSpPr txBox="1"/>
          <p:nvPr/>
        </p:nvSpPr>
        <p:spPr>
          <a:xfrm>
            <a:off x="2063315" y="1675106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CTRL-THC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4" name="CuadroTexto 53"/>
          <p:cNvSpPr txBox="1"/>
          <p:nvPr/>
        </p:nvSpPr>
        <p:spPr>
          <a:xfrm>
            <a:off x="2052821" y="2559678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VEH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5" name="CuadroTexto 54"/>
          <p:cNvSpPr txBox="1"/>
          <p:nvPr/>
        </p:nvSpPr>
        <p:spPr>
          <a:xfrm>
            <a:off x="2052821" y="3448687"/>
            <a:ext cx="6548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DHM-THC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6" name="CuadroTexto 55"/>
          <p:cNvSpPr txBox="1"/>
          <p:nvPr/>
        </p:nvSpPr>
        <p:spPr>
          <a:xfrm>
            <a:off x="1520944" y="53859"/>
            <a:ext cx="6928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31572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63144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94715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926287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157859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389431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621003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852574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PV  PNN</a:t>
            </a:r>
            <a:endParaRPr lang="es-ES_tradnl" sz="700" dirty="0">
              <a:solidFill>
                <a:schemeClr val="bg1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7" name="CuadroTexto 56"/>
          <p:cNvSpPr txBox="1"/>
          <p:nvPr/>
        </p:nvSpPr>
        <p:spPr>
          <a:xfrm>
            <a:off x="1515778" y="53860"/>
            <a:ext cx="6928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s-ES_tradnl"/>
            </a:defPPr>
            <a:lvl1pPr marL="0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231572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463144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694715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926287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157859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1389431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621003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852574" algn="l" defTabSz="463144" rtl="0" eaLnBrk="1" latinLnBrk="0" hangingPunct="1">
              <a:defRPr sz="91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s-ES_tradnl" sz="700" dirty="0" smtClean="0">
                <a:solidFill>
                  <a:srgbClr val="F60000"/>
                </a:solidFill>
                <a:latin typeface="Arial" charset="0"/>
                <a:ea typeface="Arial" charset="0"/>
                <a:cs typeface="Arial" charset="0"/>
              </a:rPr>
              <a:t>PV</a:t>
            </a:r>
            <a:r>
              <a:rPr lang="es-ES_tradnl" sz="700" dirty="0" smtClean="0">
                <a:solidFill>
                  <a:srgbClr val="C0000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700" dirty="0" smtClean="0">
                <a:solidFill>
                  <a:schemeClr val="bg1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es-ES_tradnl" sz="700" dirty="0" smtClean="0">
                <a:solidFill>
                  <a:srgbClr val="1C15F3"/>
                </a:solidFill>
                <a:latin typeface="Arial" charset="0"/>
                <a:ea typeface="Arial" charset="0"/>
                <a:cs typeface="Arial" charset="0"/>
              </a:rPr>
              <a:t>PNN</a:t>
            </a:r>
            <a:endParaRPr lang="es-ES_tradnl" sz="700" dirty="0">
              <a:solidFill>
                <a:srgbClr val="1C15F3"/>
              </a:solidFill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98384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3</TotalTime>
  <Words>26</Words>
  <Application>Microsoft Macintosh PowerPoint</Application>
  <PresentationFormat>Personalizado</PresentationFormat>
  <Paragraphs>20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2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crosoft Office User</dc:creator>
  <cp:lastModifiedBy>Microsoft Office User</cp:lastModifiedBy>
  <cp:revision>19</cp:revision>
  <dcterms:created xsi:type="dcterms:W3CDTF">2020-05-09T11:24:37Z</dcterms:created>
  <dcterms:modified xsi:type="dcterms:W3CDTF">2020-05-25T13:48:42Z</dcterms:modified>
</cp:coreProperties>
</file>